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60" r:id="rId3"/>
    <p:sldId id="261" r:id="rId4"/>
    <p:sldId id="262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57" autoAdjust="0"/>
  </p:normalViewPr>
  <p:slideViewPr>
    <p:cSldViewPr snapToGrid="0" showGuides="1">
      <p:cViewPr>
        <p:scale>
          <a:sx n="93" d="100"/>
          <a:sy n="93" d="100"/>
        </p:scale>
        <p:origin x="978" y="4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F39EB3-9EF5-4C10-8718-C9F37B516CE8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FD2D52-E613-4EEA-BDDC-93A640497B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803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b="1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FD2D52-E613-4EEA-BDDC-93A640497B7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75044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FD2D52-E613-4EEA-BDDC-93A640497B78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56662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FD2D52-E613-4EEA-BDDC-93A640497B78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1229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FD2D52-E613-4EEA-BDDC-93A640497B78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4114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8E15C5-D3CE-4044-9319-A7E9940F66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595BE8A-7442-49CE-8EB9-824059012D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C4BBCB-38AF-4487-99BB-F401C0AC0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23635B-FE9F-4DCC-82D1-16884A020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8A01E4-CA0B-41F6-9F38-E0780AF9B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141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4EB7D8-F272-40BD-B140-30FD15441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2485688-CEED-4F83-BAAD-B304E7BF95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953825-BF57-4620-946E-26DA23621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C7E8D3-F7C2-40F6-89AE-37021236F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0D947B-133D-4610-846C-CF4FBC5E7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177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D775200-B9FB-46AD-AA26-F745FEBF62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306757-C7F2-4468-881F-07361351C2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5514F3-5D8C-44D0-8889-CF1366821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DC9951-D5DD-4060-9EB8-CF7BD1CBE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B6B7B4-76D1-457E-B082-003A8AF8A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487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2ADA3B-50AF-499A-AA34-9AB8C1200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CDFED4-1A7B-4704-8D9D-AE420BB6D8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DD8D2B-0CDB-44B4-8B76-A3702BBB1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A1BC6B-45A4-4215-834E-10B829BC8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8368B4-61E9-423B-8C67-BA73CB1D8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3828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3D9E9D-71E1-44D9-8FE1-8D0C0BF74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201C96B-CE1A-4078-B4D4-649E4B0C96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1B2D66-A246-4D04-95B2-E5A9984DE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E33B18F-B0F2-4E94-A555-191B7981A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3E9ED5-F0D5-4717-B350-B9557A3FB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3045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D4A51F-B07F-45E5-B41A-74F017A595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269FA6-79DB-4940-BA78-63A2AEB4A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5CF5BC5-6134-4EBB-AA49-FDFABAFF4F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82CD4A-BD24-4D77-82FD-22C9B9530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9A7338-C698-440E-B7CB-38A0666E0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8D9A4C-179D-42BA-99AA-89BE3FFB9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6659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DDD290-272C-4856-8549-7498690502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FD0C5E7-A653-43F7-8E91-9B34071A03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BE8C934-7021-4D2D-8876-F82399BD01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4973EE3-232C-429C-98A0-961AA8695B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39B4E7D-2555-4847-8306-E340CA432A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50F208E-AB1F-4D9B-8C68-5FF0ACC87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2B5EDF3-62F7-4F90-AED1-F44C5DF21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535B749-B94A-4B1F-9DA6-FC32A4F1C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887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78F50B-70FA-4053-A693-EC1D1885D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B255E57-0AB4-47AC-8ACD-CAEDCCD9B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C908261-5801-4885-8395-7A37FA21C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7693FBE-E194-430B-961C-477041634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044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F263C71-F22B-4953-93CC-06FB701DE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98D7B26-2B6E-46B6-9433-8614D155E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199C919-9A8B-489B-9A21-9266E1130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999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4995CF-DC95-47C7-B21A-7659923E2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78B3C1-7635-4AB3-973B-C509B91EB1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22E44B9-CA78-4352-9FA2-C1B74191BB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B8053F4-58AD-4C9D-93B6-965F856BA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951A31-61C6-408D-ACEF-3FB8E376E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65A6C-EA4F-4C86-BB1D-22EB67A1C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27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A80F04-DC15-4355-B879-01C7593B9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7FE3E80-C936-4025-AF9F-C29FD1F88F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D876DDA-6E09-4D55-8E57-408B12A8E5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6209CCC-C2A0-4550-B122-EBFDB7ED4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847626E-A4D1-4FF0-9B31-3C01EC942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3AA43E-50C0-4F2E-A93A-2D9E8F437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634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B92D5FA-C8EA-4819-8075-A0318117F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B3606E-1E9B-4F99-8C61-88F3A8C093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4FC013-F1B8-490E-9F5C-F2B22097C7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5DBAB-0091-4D3E-ABCE-73E0632240C9}" type="datetimeFigureOut">
              <a:rPr lang="zh-CN" altLang="en-US" smtClean="0"/>
              <a:t>2025/5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9810DD-B760-4D29-87D3-CEDFBF9BE0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D8AE46-D400-4B6B-97C3-F3640637A8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D67BF-D466-4AED-ACEB-D4222C6C1B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260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98616DC-CAE7-434B-97F2-06C6B6945CF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000" y="1269000"/>
            <a:ext cx="2700000" cy="2160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4127287F-E669-46D6-9DEC-2864CB1E69D0}"/>
              </a:ext>
            </a:extLst>
          </p:cNvPr>
          <p:cNvSpPr/>
          <p:nvPr/>
        </p:nvSpPr>
        <p:spPr>
          <a:xfrm>
            <a:off x="241024" y="111513"/>
            <a:ext cx="11608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Figure S1</a:t>
            </a:r>
            <a:endParaRPr lang="zh-CN" altLang="en-US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B2951A12-1C70-4ADD-AF87-193EA4EB74B1}"/>
              </a:ext>
            </a:extLst>
          </p:cNvPr>
          <p:cNvSpPr/>
          <p:nvPr/>
        </p:nvSpPr>
        <p:spPr>
          <a:xfrm>
            <a:off x="3222660" y="3702140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zh-CN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sr-Latn-R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images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3A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identification of PRV</a:t>
            </a:r>
            <a:r>
              <a:rPr lang="en-US" altLang="zh-CN" kern="1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−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r>
              <a:rPr lang="en-US" altLang="zh-CN" kern="1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−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21 and PRV-Bartha K61. Viral DNA of PRV</a:t>
            </a:r>
            <a:r>
              <a:rPr lang="en-US" altLang="zh-CN" kern="1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−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r>
              <a:rPr lang="en-US" altLang="zh-CN" kern="1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−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21 and PRV-Bartha K61was extracted and PRV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amplified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660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F047125-AA72-44A5-BED2-D5834F871791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4106" y="1547615"/>
            <a:ext cx="2700000" cy="216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60E5EE9-5784-4C26-A656-BDC5FF060F9B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968" y="1547615"/>
            <a:ext cx="2700000" cy="2160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214FC071-AF24-45CB-98FD-BFAF274B138F}"/>
              </a:ext>
            </a:extLst>
          </p:cNvPr>
          <p:cNvSpPr/>
          <p:nvPr/>
        </p:nvSpPr>
        <p:spPr>
          <a:xfrm>
            <a:off x="307933" y="144295"/>
            <a:ext cx="11608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Figure S2</a:t>
            </a:r>
            <a:endParaRPr lang="zh-CN" altLang="en-US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1317B9E7-2EEA-47C6-9CFF-28143385BC83}"/>
              </a:ext>
            </a:extLst>
          </p:cNvPr>
          <p:cNvSpPr/>
          <p:nvPr/>
        </p:nvSpPr>
        <p:spPr>
          <a:xfrm>
            <a:off x="3171290" y="3908026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zh-CN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sr-Latn-R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images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5A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identification of rPRV−HL−2021. The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amplified using the genome of the rescued virus as a template. The parental PRV genome served as a positive control, and an irrelevant genome was used as a negative control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46370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6A22652C-95DA-4905-9A56-454E0882BC1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000" y="1269000"/>
            <a:ext cx="2700000" cy="2160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075A30FA-CB53-4A63-B38C-84F76BC07A9C}"/>
              </a:ext>
            </a:extLst>
          </p:cNvPr>
          <p:cNvSpPr/>
          <p:nvPr/>
        </p:nvSpPr>
        <p:spPr>
          <a:xfrm>
            <a:off x="357486" y="144295"/>
            <a:ext cx="11608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Figure S3</a:t>
            </a:r>
            <a:endParaRPr lang="zh-CN" altLang="en-US" b="1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4B7056ED-C227-400C-8282-72F12943E168}"/>
              </a:ext>
            </a:extLst>
          </p:cNvPr>
          <p:cNvSpPr/>
          <p:nvPr/>
        </p:nvSpPr>
        <p:spPr>
          <a:xfrm>
            <a:off x="3048000" y="3702543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The </a:t>
            </a:r>
            <a:r>
              <a:rPr lang="sr-Latn-R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images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6B.</a:t>
            </a:r>
            <a:r>
              <a:rPr lang="en-US" altLang="zh-CN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identification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RV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GFP. The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amplified using the genome of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RV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GFP as a template. The parental PRV genome served as a positive control, and an irrelevant genome was used as a negative control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93606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99CE009-A109-4E61-B8A0-7F4B02402F1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6000" y="1269000"/>
            <a:ext cx="2700000" cy="2160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20DA1B9C-8646-4BFE-99D4-BC13DD1CBDDD}"/>
              </a:ext>
            </a:extLst>
          </p:cNvPr>
          <p:cNvSpPr/>
          <p:nvPr/>
        </p:nvSpPr>
        <p:spPr>
          <a:xfrm>
            <a:off x="174118" y="155446"/>
            <a:ext cx="11608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Figure S4</a:t>
            </a:r>
            <a:endParaRPr lang="zh-CN" altLang="en-US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3FAC70CF-681E-4C89-B27B-0DB80A260612}"/>
              </a:ext>
            </a:extLst>
          </p:cNvPr>
          <p:cNvSpPr/>
          <p:nvPr/>
        </p:nvSpPr>
        <p:spPr>
          <a:xfrm>
            <a:off x="3274031" y="4025976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The </a:t>
            </a:r>
            <a:r>
              <a:rPr lang="sr-Latn-R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gel images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igure 7B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identification of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RV</a:t>
            </a:r>
            <a:r>
              <a:rPr lang="en-US" altLang="zh-CN" kern="100" dirty="0" err="1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−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l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US9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V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were amplified using the genome of 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RV</a:t>
            </a:r>
            <a:r>
              <a:rPr lang="en-US" altLang="zh-CN" kern="100" dirty="0" err="1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−</a:t>
            </a:r>
            <a:r>
              <a:rPr lang="en-US" altLang="zh-CN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l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r>
              <a:rPr lang="en-US" altLang="zh-CN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US9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a template. The parental PRV genome served as a positive control, and an irrelevant genome was used as a negative control.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3704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234</Words>
  <Application>Microsoft Office PowerPoint</Application>
  <PresentationFormat>宽屏</PresentationFormat>
  <Paragraphs>1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微软雅黑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M</dc:creator>
  <cp:lastModifiedBy>ZM</cp:lastModifiedBy>
  <cp:revision>9</cp:revision>
  <dcterms:created xsi:type="dcterms:W3CDTF">2025-05-25T11:10:08Z</dcterms:created>
  <dcterms:modified xsi:type="dcterms:W3CDTF">2025-05-25T15:45:55Z</dcterms:modified>
</cp:coreProperties>
</file>